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B21DF3-0317-4126-AC77-ACA3C4F079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305E9-88E0-4A14-A1DB-1C7DD23E90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8A873-10EF-4D89-BBC1-96DBB7B02C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9DAA4-3519-4747-8366-08306F25D0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1D79B-D760-4ACC-BFA2-E7ABE5C489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D9495-5137-411A-AF14-3E20EA0E09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395D1F-13B7-496D-A344-1606BCA1F7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DADD9-E3A8-4A4B-84F3-2B378101F1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E7C5E-29EF-46CA-8952-38D710F1DA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BDA05-083F-449A-AECA-1D8BC763B1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3F8ED-7AE6-416B-A8D9-B907D9D95B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59E22-024D-4B5E-BFBB-4A210784C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384DF4-F804-42BA-ABCC-1E5415ABBA6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2"/>
          <p:cNvSpPr/>
          <p:nvPr/>
        </p:nvSpPr>
        <p:spPr>
          <a:xfrm>
            <a:off x="3286800" y="62064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3"/>
          <p:cNvSpPr/>
          <p:nvPr/>
        </p:nvSpPr>
        <p:spPr>
          <a:xfrm>
            <a:off x="4291920" y="26028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4"/>
          <p:cNvSpPr/>
          <p:nvPr/>
        </p:nvSpPr>
        <p:spPr>
          <a:xfrm>
            <a:off x="4059360" y="6308640"/>
            <a:ext cx="102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OTTO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1" descr=""/>
          <p:cNvPicPr/>
          <p:nvPr/>
        </p:nvPicPr>
        <p:blipFill>
          <a:blip r:embed="rId1"/>
          <a:stretch/>
        </p:blipFill>
        <p:spPr>
          <a:xfrm>
            <a:off x="611280" y="1628640"/>
            <a:ext cx="7800840" cy="343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グループ化 36"/>
          <p:cNvGrpSpPr/>
          <p:nvPr/>
        </p:nvGrpSpPr>
        <p:grpSpPr>
          <a:xfrm>
            <a:off x="5866920" y="4464000"/>
            <a:ext cx="360360" cy="647640"/>
            <a:chOff x="5866920" y="4464000"/>
            <a:chExt cx="360360" cy="647640"/>
          </a:xfrm>
        </p:grpSpPr>
        <p:sp>
          <p:nvSpPr>
            <p:cNvPr id="46" name="右矢印 34"/>
            <p:cNvSpPr/>
            <p:nvPr/>
          </p:nvSpPr>
          <p:spPr>
            <a:xfrm rot="5400000">
              <a:off x="5749560" y="4633920"/>
              <a:ext cx="594720" cy="360360"/>
            </a:xfrm>
            <a:prstGeom prst="rightArrow">
              <a:avLst>
                <a:gd name="adj1" fmla="val 50000"/>
                <a:gd name="adj2" fmla="val 58939"/>
              </a:avLst>
            </a:prstGeom>
            <a:noFill/>
            <a:ln w="255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正方形/長方形 35"/>
            <p:cNvSpPr/>
            <p:nvPr/>
          </p:nvSpPr>
          <p:spPr>
            <a:xfrm>
              <a:off x="5939280" y="4464000"/>
              <a:ext cx="216360" cy="84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" name="テキスト ボックス 33"/>
          <p:cNvSpPr/>
          <p:nvPr/>
        </p:nvSpPr>
        <p:spPr>
          <a:xfrm>
            <a:off x="3286800" y="62064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グループ化 38"/>
          <p:cNvGrpSpPr/>
          <p:nvPr/>
        </p:nvGrpSpPr>
        <p:grpSpPr>
          <a:xfrm>
            <a:off x="2195640" y="1341360"/>
            <a:ext cx="4752720" cy="4535280"/>
            <a:chOff x="2195640" y="1341360"/>
            <a:chExt cx="4752720" cy="4535280"/>
          </a:xfrm>
        </p:grpSpPr>
        <p:sp>
          <p:nvSpPr>
            <p:cNvPr id="50" name="正方形/長方形 2"/>
            <p:cNvSpPr/>
            <p:nvPr/>
          </p:nvSpPr>
          <p:spPr>
            <a:xfrm>
              <a:off x="2697480" y="1341360"/>
              <a:ext cx="3585960" cy="3600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ligible for this study n=24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正方形/長方形 5"/>
            <p:cNvSpPr/>
            <p:nvPr/>
          </p:nvSpPr>
          <p:spPr>
            <a:xfrm>
              <a:off x="2195640" y="2709360"/>
              <a:ext cx="1434240" cy="525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AP regimen n=98 (85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正方形/長方形 6"/>
            <p:cNvSpPr/>
            <p:nvPr/>
          </p:nvSpPr>
          <p:spPr>
            <a:xfrm>
              <a:off x="5351400" y="2709360"/>
              <a:ext cx="1434240" cy="525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sec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13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正方形/長方形 47"/>
            <p:cNvSpPr/>
            <p:nvPr/>
          </p:nvSpPr>
          <p:spPr>
            <a:xfrm>
              <a:off x="3773520" y="2709360"/>
              <a:ext cx="1434240" cy="525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P+RT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正方形/長方形 59"/>
            <p:cNvSpPr/>
            <p:nvPr/>
          </p:nvSpPr>
          <p:spPr>
            <a:xfrm>
              <a:off x="5351400" y="3861000"/>
              <a:ext cx="1434240" cy="525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urative resect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13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正方形/長方形 95"/>
            <p:cNvSpPr/>
            <p:nvPr/>
          </p:nvSpPr>
          <p:spPr>
            <a:xfrm>
              <a:off x="3773520" y="3861000"/>
              <a:ext cx="1434240" cy="525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urative resect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正方形/長方形 96"/>
            <p:cNvSpPr/>
            <p:nvPr/>
          </p:nvSpPr>
          <p:spPr>
            <a:xfrm>
              <a:off x="2195640" y="3861000"/>
              <a:ext cx="1434240" cy="525240"/>
            </a:xfrm>
            <a:prstGeom prst="rect">
              <a:avLst/>
            </a:prstGeom>
            <a:noFill/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Curative resect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n=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正方形/長方形 97"/>
            <p:cNvSpPr/>
            <p:nvPr/>
          </p:nvSpPr>
          <p:spPr>
            <a:xfrm>
              <a:off x="2195640" y="3861000"/>
              <a:ext cx="1434240" cy="20156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sec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94 (81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14000"/>
                </a:lnSpc>
                <a:buClr>
                  <a:srgbClr val="000000"/>
                </a:buClr>
                <a:buFont typeface="Times New Roman"/>
                <a:buAutoNum type="arabicPeriod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urative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83 (70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14000"/>
                </a:lnSpc>
                <a:buClr>
                  <a:srgbClr val="000000"/>
                </a:buClr>
                <a:buFont typeface="Times New Roman"/>
                <a:buAutoNum type="arabicPeriod" startAt="2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n-curativ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11 (11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t resect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4 (4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14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8" name="カギ線コネクタ 101"/>
            <p:cNvCxnSpPr>
              <a:stCxn id="50" idx="2"/>
              <a:endCxn id="53" idx="0"/>
            </p:cNvCxnSpPr>
            <p:nvPr/>
          </p:nvCxnSpPr>
          <p:spPr>
            <a:xfrm rot="5400000">
              <a:off x="3986280" y="2204640"/>
              <a:ext cx="1008360" cy="1080"/>
            </a:xfrm>
            <a:prstGeom prst="bentConnector3">
              <a:avLst>
                <a:gd name="adj1" fmla="val 50000"/>
              </a:avLst>
            </a:prstGeom>
            <a:ln w="19080">
              <a:solidFill>
                <a:srgbClr val="000000"/>
              </a:solidFill>
              <a:miter/>
            </a:ln>
          </p:spPr>
        </p:cxnSp>
        <p:cxnSp>
          <p:nvCxnSpPr>
            <p:cNvPr id="59" name="カギ線コネクタ 103"/>
            <p:cNvCxnSpPr>
              <a:stCxn id="50" idx="2"/>
              <a:endCxn id="52" idx="0"/>
            </p:cNvCxnSpPr>
            <p:nvPr/>
          </p:nvCxnSpPr>
          <p:spPr>
            <a:xfrm flipH="1" rot="16200000">
              <a:off x="4775400" y="1415880"/>
              <a:ext cx="1008360" cy="1578240"/>
            </a:xfrm>
            <a:prstGeom prst="bentConnector3">
              <a:avLst>
                <a:gd name="adj1" fmla="val 50000"/>
              </a:avLst>
            </a:prstGeom>
            <a:ln w="19080">
              <a:solidFill>
                <a:srgbClr val="000000"/>
              </a:solidFill>
              <a:miter/>
            </a:ln>
          </p:spPr>
        </p:cxnSp>
        <p:cxnSp>
          <p:nvCxnSpPr>
            <p:cNvPr id="60" name="カギ線コネクタ 105"/>
            <p:cNvCxnSpPr>
              <a:stCxn id="50" idx="2"/>
              <a:endCxn id="51" idx="0"/>
            </p:cNvCxnSpPr>
            <p:nvPr/>
          </p:nvCxnSpPr>
          <p:spPr>
            <a:xfrm rot="5400000">
              <a:off x="3197160" y="1415880"/>
              <a:ext cx="1008360" cy="1578600"/>
            </a:xfrm>
            <a:prstGeom prst="bentConnector3">
              <a:avLst>
                <a:gd name="adj1" fmla="val 50000"/>
              </a:avLst>
            </a:prstGeom>
            <a:ln w="19080">
              <a:solidFill>
                <a:srgbClr val="000000"/>
              </a:solidFill>
              <a:miter/>
            </a:ln>
          </p:spPr>
        </p:cxnSp>
        <p:sp>
          <p:nvSpPr>
            <p:cNvPr id="61" name="直線コネクタ 107"/>
            <p:cNvSpPr/>
            <p:nvPr/>
          </p:nvSpPr>
          <p:spPr>
            <a:xfrm>
              <a:off x="2912760" y="3234600"/>
              <a:ext cx="0" cy="626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直線コネクタ 111"/>
            <p:cNvSpPr/>
            <p:nvPr/>
          </p:nvSpPr>
          <p:spPr>
            <a:xfrm>
              <a:off x="4490640" y="3234600"/>
              <a:ext cx="0" cy="626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直線コネクタ 113"/>
            <p:cNvSpPr/>
            <p:nvPr/>
          </p:nvSpPr>
          <p:spPr>
            <a:xfrm>
              <a:off x="6068520" y="3234600"/>
              <a:ext cx="0" cy="626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4" name="グループ化 131" descr=""/>
            <p:cNvPicPr/>
            <p:nvPr/>
          </p:nvPicPr>
          <p:blipFill>
            <a:blip r:embed="rId1"/>
            <a:stretch/>
          </p:blipFill>
          <p:spPr>
            <a:xfrm>
              <a:off x="2467440" y="3706560"/>
              <a:ext cx="4480920" cy="118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テキスト ボックス 138"/>
            <p:cNvSpPr/>
            <p:nvPr/>
          </p:nvSpPr>
          <p:spPr>
            <a:xfrm>
              <a:off x="5351400" y="5157000"/>
              <a:ext cx="1408320" cy="672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sected Grou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=22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cluded 3 CR cas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テキスト ボックス 140"/>
            <p:cNvSpPr/>
            <p:nvPr/>
          </p:nvSpPr>
          <p:spPr>
            <a:xfrm>
              <a:off x="3773520" y="5373000"/>
              <a:ext cx="1441800" cy="489600"/>
            </a:xfrm>
            <a:prstGeom prst="rect">
              <a:avLst/>
            </a:prstGeom>
            <a:solidFill>
              <a:srgbClr val="f2f2f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  ) is the number of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iopsied Grou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テキスト ボックス 142"/>
          <p:cNvSpPr/>
          <p:nvPr/>
        </p:nvSpPr>
        <p:spPr>
          <a:xfrm>
            <a:off x="4291920" y="26028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143"/>
          <p:cNvSpPr/>
          <p:nvPr/>
        </p:nvSpPr>
        <p:spPr>
          <a:xfrm>
            <a:off x="4059360" y="6308640"/>
            <a:ext cx="102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OTTO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39"/>
          <p:cNvSpPr/>
          <p:nvPr/>
        </p:nvSpPr>
        <p:spPr>
          <a:xfrm>
            <a:off x="1042920" y="2708280"/>
            <a:ext cx="1081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rst-li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eatme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647640" y="1197000"/>
            <a:ext cx="8102520" cy="3987720"/>
          </a:xfrm>
          <a:prstGeom prst="rect">
            <a:avLst/>
          </a:prstGeom>
          <a:ln w="0">
            <a:noFill/>
          </a:ln>
        </p:spPr>
      </p:pic>
      <p:sp>
        <p:nvSpPr>
          <p:cNvPr id="71" name="テキスト ボックス 2"/>
          <p:cNvSpPr/>
          <p:nvPr/>
        </p:nvSpPr>
        <p:spPr>
          <a:xfrm>
            <a:off x="3286800" y="62064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テキスト ボックス 3"/>
          <p:cNvSpPr/>
          <p:nvPr/>
        </p:nvSpPr>
        <p:spPr>
          <a:xfrm>
            <a:off x="4291920" y="26028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4"/>
          <p:cNvSpPr/>
          <p:nvPr/>
        </p:nvSpPr>
        <p:spPr>
          <a:xfrm>
            <a:off x="4059360" y="6308640"/>
            <a:ext cx="102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OTTO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4" name=""/>
          <p:cNvGraphicFramePr/>
          <p:nvPr/>
        </p:nvGraphicFramePr>
        <p:xfrm>
          <a:off x="34920" y="4941720"/>
          <a:ext cx="4465800" cy="530280"/>
        </p:xfrm>
        <a:graphic>
          <a:graphicData uri="http://schemas.openxmlformats.org/drawingml/2006/table">
            <a:tbl>
              <a:tblPr/>
              <a:tblGrid>
                <a:gridCol w="235080"/>
                <a:gridCol w="672840"/>
                <a:gridCol w="507960"/>
                <a:gridCol w="508320"/>
                <a:gridCol w="507960"/>
                <a:gridCol w="507960"/>
                <a:gridCol w="507960"/>
                <a:gridCol w="509400"/>
                <a:gridCol w="508320"/>
              </a:tblGrid>
              <a:tr h="177120"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 at Ris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1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ga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1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si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5" name=""/>
          <p:cNvGraphicFramePr/>
          <p:nvPr/>
        </p:nvGraphicFramePr>
        <p:xfrm>
          <a:off x="4390920" y="4941720"/>
          <a:ext cx="4465800" cy="530280"/>
        </p:xfrm>
        <a:graphic>
          <a:graphicData uri="http://schemas.openxmlformats.org/drawingml/2006/table">
            <a:tbl>
              <a:tblPr/>
              <a:tblGrid>
                <a:gridCol w="235080"/>
                <a:gridCol w="673200"/>
                <a:gridCol w="507960"/>
                <a:gridCol w="507960"/>
                <a:gridCol w="507960"/>
                <a:gridCol w="507960"/>
                <a:gridCol w="507960"/>
                <a:gridCol w="507960"/>
                <a:gridCol w="509760"/>
              </a:tblGrid>
              <a:tr h="177120"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 at Ris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1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ga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1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sit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6" name=""/>
          <p:cNvGraphicFramePr/>
          <p:nvPr/>
        </p:nvGraphicFramePr>
        <p:xfrm>
          <a:off x="2195640" y="1557360"/>
          <a:ext cx="2520720" cy="971640"/>
        </p:xfrm>
        <a:graphic>
          <a:graphicData uri="http://schemas.openxmlformats.org/drawingml/2006/table">
            <a:tbl>
              <a:tblPr/>
              <a:tblGrid>
                <a:gridCol w="485640"/>
                <a:gridCol w="485640"/>
                <a:gridCol w="1117800"/>
                <a:gridCol w="431640"/>
              </a:tblGrid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 Ev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1616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53 [0.308-0.979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7" name=""/>
          <p:cNvGraphicFramePr/>
          <p:nvPr/>
        </p:nvGraphicFramePr>
        <p:xfrm>
          <a:off x="6300720" y="1557360"/>
          <a:ext cx="2519280" cy="971640"/>
        </p:xfrm>
        <a:graphic>
          <a:graphicData uri="http://schemas.openxmlformats.org/drawingml/2006/table">
            <a:tbl>
              <a:tblPr/>
              <a:tblGrid>
                <a:gridCol w="486000"/>
                <a:gridCol w="485640"/>
                <a:gridCol w="1116000"/>
                <a:gridCol w="431640"/>
              </a:tblGrid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 Ev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1616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93 [0.276-0.861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62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28T13:22:04Z</dcterms:created>
  <dc:creator>Hiromichi Miyagaki</dc:creator>
  <dc:description/>
  <dc:language>en-US</dc:language>
  <cp:lastModifiedBy>j.jagadheesh</cp:lastModifiedBy>
  <dcterms:modified xsi:type="dcterms:W3CDTF">2012-02-09T12:15:14Z</dcterms:modified>
  <cp:revision>33</cp:revision>
  <dc:subject/>
  <dc:title>スライド 1</dc:title>
</cp:coreProperties>
</file>